
<file path=[Content_Types].xml><?xml version="1.0" encoding="utf-8"?>
<Types xmlns="http://schemas.openxmlformats.org/package/2006/content-types">
  <Default Extension="bin" ContentType="application/vnd.openxmlformats-officedocument.presentationml.printerSettings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457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5" d="100"/>
          <a:sy n="85" d="100"/>
        </p:scale>
        <p:origin x="-120" y="-944"/>
      </p:cViewPr>
      <p:guideLst>
        <p:guide orient="horz" pos="144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1.xml"/><Relationship Id="rId3" Type="http://schemas.openxmlformats.org/officeDocument/2006/relationships/printerSettings" Target="printerSettings/printerSettings1.bin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openxmlformats.org/officeDocument/2006/relationships/customXml" Target="../customXml/item3.xml"/><Relationship Id="rId4" Type="http://schemas.openxmlformats.org/officeDocument/2006/relationships/presProps" Target="presProps.xml"/><Relationship Id="rId9" Type="http://schemas.openxmlformats.org/officeDocument/2006/relationships/customXml" Target="../customXml/item2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erit\Documents\manuscripts\liz%20rnaseq\data\sept%202015%20revision\senescence%20vs%20AD%20down%20gene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0824016655377032"/>
          <c:y val="0.0878553952057332"/>
          <c:w val="0.778104668310463"/>
          <c:h val="0.78136525454216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all DAVID'!$B$14</c:f>
              <c:strCache>
                <c:ptCount val="1"/>
                <c:pt idx="0">
                  <c:v>senescence</c:v>
                </c:pt>
              </c:strCache>
            </c:strRef>
          </c:tx>
          <c:spPr>
            <a:solidFill>
              <a:srgbClr val="C00000"/>
            </a:solidFill>
          </c:spPr>
          <c:invertIfNegative val="0"/>
          <c:cat>
            <c:strRef>
              <c:f>'all DAVID'!$A$15:$A$24</c:f>
              <c:strCache>
                <c:ptCount val="10"/>
                <c:pt idx="0">
                  <c:v>RORB</c:v>
                </c:pt>
                <c:pt idx="1">
                  <c:v>BCL2</c:v>
                </c:pt>
                <c:pt idx="2">
                  <c:v>NTRK2</c:v>
                </c:pt>
                <c:pt idx="3">
                  <c:v>LINGO1</c:v>
                </c:pt>
                <c:pt idx="4">
                  <c:v>RND1</c:v>
                </c:pt>
                <c:pt idx="5">
                  <c:v>NAALAD2</c:v>
                </c:pt>
                <c:pt idx="6">
                  <c:v>PDE7B</c:v>
                </c:pt>
                <c:pt idx="7">
                  <c:v>FGF9</c:v>
                </c:pt>
                <c:pt idx="8">
                  <c:v>FGF12</c:v>
                </c:pt>
                <c:pt idx="9">
                  <c:v>ADORA1</c:v>
                </c:pt>
              </c:strCache>
            </c:strRef>
          </c:cat>
          <c:val>
            <c:numRef>
              <c:f>'all DAVID'!$B$15:$B$24</c:f>
              <c:numCache>
                <c:formatCode>General</c:formatCode>
                <c:ptCount val="10"/>
                <c:pt idx="0">
                  <c:v>0.215202437746551</c:v>
                </c:pt>
                <c:pt idx="1">
                  <c:v>0.520561949102933</c:v>
                </c:pt>
                <c:pt idx="2">
                  <c:v>0.0882714538825376</c:v>
                </c:pt>
                <c:pt idx="3">
                  <c:v>0.150787729242248</c:v>
                </c:pt>
                <c:pt idx="4">
                  <c:v>0.0261755225071852</c:v>
                </c:pt>
                <c:pt idx="5">
                  <c:v>0.231251532666711</c:v>
                </c:pt>
                <c:pt idx="6">
                  <c:v>0.231124670331366</c:v>
                </c:pt>
                <c:pt idx="7">
                  <c:v>0.190007439645125</c:v>
                </c:pt>
                <c:pt idx="8">
                  <c:v>0.261652230525224</c:v>
                </c:pt>
                <c:pt idx="9">
                  <c:v>0.112315701748022</c:v>
                </c:pt>
              </c:numCache>
            </c:numRef>
          </c:val>
        </c:ser>
        <c:ser>
          <c:idx val="1"/>
          <c:order val="1"/>
          <c:tx>
            <c:strRef>
              <c:f>'all DAVID'!$C$14</c:f>
              <c:strCache>
                <c:ptCount val="1"/>
                <c:pt idx="0">
                  <c:v>AD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cat>
            <c:strRef>
              <c:f>'all DAVID'!$A$15:$A$24</c:f>
              <c:strCache>
                <c:ptCount val="10"/>
                <c:pt idx="0">
                  <c:v>RORB</c:v>
                </c:pt>
                <c:pt idx="1">
                  <c:v>BCL2</c:v>
                </c:pt>
                <c:pt idx="2">
                  <c:v>NTRK2</c:v>
                </c:pt>
                <c:pt idx="3">
                  <c:v>LINGO1</c:v>
                </c:pt>
                <c:pt idx="4">
                  <c:v>RND1</c:v>
                </c:pt>
                <c:pt idx="5">
                  <c:v>NAALAD2</c:v>
                </c:pt>
                <c:pt idx="6">
                  <c:v>PDE7B</c:v>
                </c:pt>
                <c:pt idx="7">
                  <c:v>FGF9</c:v>
                </c:pt>
                <c:pt idx="8">
                  <c:v>FGF12</c:v>
                </c:pt>
                <c:pt idx="9">
                  <c:v>ADORA1</c:v>
                </c:pt>
              </c:strCache>
            </c:strRef>
          </c:cat>
          <c:val>
            <c:numRef>
              <c:f>'all DAVID'!$C$15:$C$24</c:f>
              <c:numCache>
                <c:formatCode>General</c:formatCode>
                <c:ptCount val="10"/>
                <c:pt idx="0">
                  <c:v>0.50251256281407</c:v>
                </c:pt>
                <c:pt idx="1">
                  <c:v>0.53475935828877</c:v>
                </c:pt>
                <c:pt idx="2">
                  <c:v>0.37593984962406</c:v>
                </c:pt>
                <c:pt idx="3">
                  <c:v>0.347222222222222</c:v>
                </c:pt>
                <c:pt idx="4">
                  <c:v>0.431034482758621</c:v>
                </c:pt>
                <c:pt idx="5">
                  <c:v>0.666666666666667</c:v>
                </c:pt>
                <c:pt idx="6">
                  <c:v>0.483091787439614</c:v>
                </c:pt>
                <c:pt idx="7">
                  <c:v>0.510204081632653</c:v>
                </c:pt>
                <c:pt idx="8">
                  <c:v>0.609756097560976</c:v>
                </c:pt>
                <c:pt idx="9">
                  <c:v>0.60975609756097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35977864"/>
        <c:axId val="335980904"/>
      </c:barChart>
      <c:catAx>
        <c:axId val="33597786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1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335980904"/>
        <c:crosses val="autoZero"/>
        <c:auto val="1"/>
        <c:lblAlgn val="ctr"/>
        <c:lblOffset val="100"/>
        <c:noMultiLvlLbl val="0"/>
      </c:catAx>
      <c:valAx>
        <c:axId val="33598090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200" b="0">
                    <a:latin typeface="Arial" panose="020B0604020202020204" pitchFamily="34" charset="0"/>
                    <a:cs typeface="Arial" panose="020B0604020202020204" pitchFamily="34" charset="0"/>
                  </a:rPr>
                  <a:t>expression (fraction of control)</a:t>
                </a:r>
              </a:p>
            </c:rich>
          </c:tx>
          <c:layout>
            <c:manualLayout>
              <c:xMode val="edge"/>
              <c:yMode val="edge"/>
              <c:x val="0.00801587113706169"/>
              <c:y val="0.205179423517907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335977864"/>
        <c:crosses val="autoZero"/>
        <c:crossBetween val="between"/>
      </c:valAx>
    </c:plotArea>
    <c:legend>
      <c:legendPos val="r"/>
      <c:layout/>
      <c:overlay val="0"/>
      <c:txPr>
        <a:bodyPr/>
        <a:lstStyle/>
        <a:p>
          <a:pPr>
            <a:defRPr sz="1200">
              <a:latin typeface="Arial" panose="020B0604020202020204" pitchFamily="34" charset="0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420284"/>
            <a:ext cx="7772400" cy="9800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2590800"/>
            <a:ext cx="6400800" cy="11684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D83E3-87F2-44C5-AD8C-CBF3F5DC42C2}" type="datetimeFigureOut">
              <a:rPr lang="en-US" smtClean="0"/>
              <a:t>8/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4BF66-3656-4A9C-89F2-F3677178A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35960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D83E3-87F2-44C5-AD8C-CBF3F5DC42C2}" type="datetimeFigureOut">
              <a:rPr lang="en-US" smtClean="0"/>
              <a:t>8/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4BF66-3656-4A9C-89F2-F3677178A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7903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183092"/>
            <a:ext cx="2057400" cy="39010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183092"/>
            <a:ext cx="6019800" cy="39010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D83E3-87F2-44C5-AD8C-CBF3F5DC42C2}" type="datetimeFigureOut">
              <a:rPr lang="en-US" smtClean="0"/>
              <a:t>8/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4BF66-3656-4A9C-89F2-F3677178A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8003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D83E3-87F2-44C5-AD8C-CBF3F5DC42C2}" type="datetimeFigureOut">
              <a:rPr lang="en-US" smtClean="0"/>
              <a:t>8/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4BF66-3656-4A9C-89F2-F3677178A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15953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2937934"/>
            <a:ext cx="7772400" cy="90805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1937809"/>
            <a:ext cx="7772400" cy="1000125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D83E3-87F2-44C5-AD8C-CBF3F5DC42C2}" type="datetimeFigureOut">
              <a:rPr lang="en-US" smtClean="0"/>
              <a:t>8/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4BF66-3656-4A9C-89F2-F3677178A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13605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066800"/>
            <a:ext cx="4038600" cy="301730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066800"/>
            <a:ext cx="4038600" cy="301730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D83E3-87F2-44C5-AD8C-CBF3F5DC42C2}" type="datetimeFigureOut">
              <a:rPr lang="en-US" smtClean="0"/>
              <a:t>8/5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4BF66-3656-4A9C-89F2-F3677178A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99183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023409"/>
            <a:ext cx="4040188" cy="42650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1449917"/>
            <a:ext cx="4040188" cy="263419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023409"/>
            <a:ext cx="4041775" cy="42650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1449917"/>
            <a:ext cx="4041775" cy="263419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D83E3-87F2-44C5-AD8C-CBF3F5DC42C2}" type="datetimeFigureOut">
              <a:rPr lang="en-US" smtClean="0"/>
              <a:t>8/5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4BF66-3656-4A9C-89F2-F3677178A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85877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D83E3-87F2-44C5-AD8C-CBF3F5DC42C2}" type="datetimeFigureOut">
              <a:rPr lang="en-US" smtClean="0"/>
              <a:t>8/5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4BF66-3656-4A9C-89F2-F3677178A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31189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D83E3-87F2-44C5-AD8C-CBF3F5DC42C2}" type="datetimeFigureOut">
              <a:rPr lang="en-US" smtClean="0"/>
              <a:t>8/5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4BF66-3656-4A9C-89F2-F3677178A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65263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182033"/>
            <a:ext cx="3008313" cy="7747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182034"/>
            <a:ext cx="5111750" cy="390207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956734"/>
            <a:ext cx="3008313" cy="3127375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D83E3-87F2-44C5-AD8C-CBF3F5DC42C2}" type="datetimeFigureOut">
              <a:rPr lang="en-US" smtClean="0"/>
              <a:t>8/5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4BF66-3656-4A9C-89F2-F3677178A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27656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3200400"/>
            <a:ext cx="5486400" cy="37782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408517"/>
            <a:ext cx="5486400" cy="27432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3578225"/>
            <a:ext cx="5486400" cy="536575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D83E3-87F2-44C5-AD8C-CBF3F5DC42C2}" type="datetimeFigureOut">
              <a:rPr lang="en-US" smtClean="0"/>
              <a:t>8/5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4BF66-3656-4A9C-89F2-F3677178A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4744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4" Type="http://schemas.openxmlformats.org/officeDocument/2006/relationships/slideLayout" Target="../slideLayouts/slideLayout4.xml"/><Relationship Id="rId10" Type="http://schemas.openxmlformats.org/officeDocument/2006/relationships/slideLayout" Target="../slideLayouts/slideLayout10.xml"/><Relationship Id="rId5" Type="http://schemas.openxmlformats.org/officeDocument/2006/relationships/slideLayout" Target="../slideLayouts/slideLayout5.xml"/><Relationship Id="rId7" Type="http://schemas.openxmlformats.org/officeDocument/2006/relationships/slideLayout" Target="../slideLayouts/slideLayout7.xml"/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9" Type="http://schemas.openxmlformats.org/officeDocument/2006/relationships/slideLayout" Target="../slideLayouts/slideLayout9.xml"/><Relationship Id="rId3" Type="http://schemas.openxmlformats.org/officeDocument/2006/relationships/slideLayout" Target="../slideLayouts/slideLayout3.xml"/><Relationship Id="rId6" Type="http://schemas.openxmlformats.org/officeDocument/2006/relationships/slideLayout" Target="../slideLayouts/slideLayout6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183092"/>
            <a:ext cx="8229600" cy="762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066800"/>
            <a:ext cx="8229600" cy="301730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4237567"/>
            <a:ext cx="2133600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6D83E3-87F2-44C5-AD8C-CBF3F5DC42C2}" type="datetimeFigureOut">
              <a:rPr lang="en-US" smtClean="0"/>
              <a:t>8/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4237567"/>
            <a:ext cx="2895600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4237567"/>
            <a:ext cx="2133600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F4BF66-3656-4A9C-89F2-F3677178AD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16814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931" y="3795712"/>
            <a:ext cx="89916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ld changes in the genes commonly downregulated in astrocytes in senescence and in AD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ld changes in gene expression going from pre-senescent to senescent astrocytes (red columns), and from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raak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age I-II control patient astrocytes to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raak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age V-VI AD patient astrocytes (black columns). Expression values are shown as fraction of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pre-senescent astrocytes or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raak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tage I-II patients)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09007244"/>
              </p:ext>
            </p:extLst>
          </p:nvPr>
        </p:nvGraphicFramePr>
        <p:xfrm>
          <a:off x="155331" y="0"/>
          <a:ext cx="8617404" cy="37957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6289879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4D4B5B85777C1B42AA7B2E00829C049E" ma:contentTypeVersion="7" ma:contentTypeDescription="Create a new document." ma:contentTypeScope="" ma:versionID="95e1889000582fa1ea767959ed6c08ca">
  <xsd:schema xmlns:xsd="http://www.w3.org/2001/XMLSchema" xmlns:p="http://schemas.microsoft.com/office/2006/metadata/properties" xmlns:ns2="64f0ecf7-d19c-4b88-abc0-1645d5999ad2" targetNamespace="http://schemas.microsoft.com/office/2006/metadata/properties" ma:root="true" ma:fieldsID="1970cc853a1240edc583d79f32ace129" ns2:_="">
    <xsd:import namespace="64f0ecf7-d19c-4b88-abc0-1645d5999ad2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64f0ecf7-d19c-4b88-abc0-1645d5999ad2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Id xmlns="64f0ecf7-d19c-4b88-abc0-1645d5999ad2">Presentation 3.PPTX</DocumentId>
    <IsDeleted xmlns="64f0ecf7-d19c-4b88-abc0-1645d5999ad2">false</IsDeleted>
    <StageName xmlns="64f0ecf7-d19c-4b88-abc0-1645d5999ad2" xsi:nil="true"/>
    <TitleName xmlns="64f0ecf7-d19c-4b88-abc0-1645d5999ad2">Presentation 3.PPTX</TitleName>
    <DocumentType xmlns="64f0ecf7-d19c-4b88-abc0-1645d5999ad2">Presentation</DocumentType>
    <FileFormat xmlns="64f0ecf7-d19c-4b88-abc0-1645d5999ad2">PPTX</FileFormat>
    <Checked_x0020_Out_x0020_To xmlns="64f0ecf7-d19c-4b88-abc0-1645d5999ad2">
      <UserInfo>
        <DisplayName/>
        <AccountId xsi:nil="true"/>
        <AccountType/>
      </UserInfo>
    </Checked_x0020_Out_x0020_To>
  </documentManagement>
</p:properties>
</file>

<file path=customXml/itemProps1.xml><?xml version="1.0" encoding="utf-8"?>
<ds:datastoreItem xmlns:ds="http://schemas.openxmlformats.org/officeDocument/2006/customXml" ds:itemID="{D5BB9F5D-D5B4-4508-98EE-936FCF067FCD}"/>
</file>

<file path=customXml/itemProps2.xml><?xml version="1.0" encoding="utf-8"?>
<ds:datastoreItem xmlns:ds="http://schemas.openxmlformats.org/officeDocument/2006/customXml" ds:itemID="{1FC1FD5C-3CF4-4586-82B4-F9824220D39F}"/>
</file>

<file path=customXml/itemProps3.xml><?xml version="1.0" encoding="utf-8"?>
<ds:datastoreItem xmlns:ds="http://schemas.openxmlformats.org/officeDocument/2006/customXml" ds:itemID="{27B2487D-8CE0-4F7E-BDA1-919B2898E3E7}"/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89</Words>
  <Application>Microsoft Macintosh PowerPoint</Application>
  <PresentationFormat>Custom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Drexel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erit Tuzer</dc:creator>
  <cp:lastModifiedBy>Claudio  Torres</cp:lastModifiedBy>
  <cp:revision>3</cp:revision>
  <dcterms:created xsi:type="dcterms:W3CDTF">2016-08-01T16:58:15Z</dcterms:created>
  <dcterms:modified xsi:type="dcterms:W3CDTF">2016-08-05T14:01:0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4D4B5B85777C1B42AA7B2E00829C049E</vt:lpwstr>
  </property>
</Properties>
</file>